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C79A19-52EE-4FE3-AE22-15B070C3193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CB804A-BC25-4D75-BB0A-7BE636EEC44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37BD50-D092-4386-A86D-7BE140AFD8E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B3B565-5CDC-4F4D-BA34-72D5EE46512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24ADCC-0DDB-43B0-B01B-6BE695107C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9BAD33-89ED-4D93-9B79-14B94E7B1C8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067B91-3D0C-473E-A0CF-CF0A8509BCA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AE53C4-BDFE-4216-BAD3-073B33A195F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259C2B-0389-4C71-8C11-4E99DC084D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FBE0DE-6103-42C6-AA45-23AAA48B2E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57FDB0-F865-48B7-9A02-88C8BABA20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A00467-5614-44DE-AD18-FC56EDBB41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88E5615-DCB3-4E08-87A0-AB0E30A71D12}" type="datetime"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D912AFD-9781-4A9B-904F-A30AB6BEF7AE}" type="slidenum"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1" descr="M:\PhD M.Leite\AnxA1\BCACID_Scores\Scope Pictures\20p_20X_ESTHER_Mamma5A_1.5.jpg"/>
          <p:cNvPicPr/>
          <p:nvPr/>
        </p:nvPicPr>
        <p:blipFill>
          <a:blip r:embed="rId1"/>
          <a:srcRect l="10870" t="1048" r="49001" b="33127"/>
          <a:stretch/>
        </p:blipFill>
        <p:spPr>
          <a:xfrm>
            <a:off x="3645000" y="1763640"/>
            <a:ext cx="1963800" cy="1790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2" name="Picture 39" descr="M:\PhD M.Leite\AnxA1\BCACID_Scores\Scope Pictures\60p_20X_RBCS_TMA2a_14.8.jpg"/>
          <p:cNvPicPr/>
          <p:nvPr/>
        </p:nvPicPr>
        <p:blipFill>
          <a:blip r:embed="rId2"/>
          <a:srcRect l="32124" t="699" r="27876" b="33591"/>
          <a:stretch/>
        </p:blipFill>
        <p:spPr>
          <a:xfrm>
            <a:off x="1387440" y="3841920"/>
            <a:ext cx="1957320" cy="17874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3" name="TextBox 19"/>
          <p:cNvSpPr/>
          <p:nvPr/>
        </p:nvSpPr>
        <p:spPr>
          <a:xfrm>
            <a:off x="1268280" y="5792760"/>
            <a:ext cx="4402440" cy="1265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1: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mmunohistochemistry for Annexin A1 (ANXA1) expression in breast tumors.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)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XA1 is negative in ductal carcinoma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 situ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ells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ut normal myoepithelial cells are positively stained (arrows).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)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XA1 is weakly stained in ~20% of tumor cells; the strongly stained area is stroma.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)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 moderate ANXA1 stain was found in ~60% of the cells.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)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 strong ANXA1 stain is observed in 100% of the tumor cells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Picture 10" descr="M:\PhD M.Leite\AnxA1\BCACID_Scores\Scope Pictures\neg_20X_MCBCS 15N.jpg"/>
          <p:cNvPicPr/>
          <p:nvPr/>
        </p:nvPicPr>
        <p:blipFill>
          <a:blip r:embed="rId3"/>
          <a:srcRect l="18412" t="40724" r="46076" b="0"/>
          <a:stretch/>
        </p:blipFill>
        <p:spPr>
          <a:xfrm>
            <a:off x="1407960" y="1765440"/>
            <a:ext cx="1944720" cy="1780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grpSp>
        <p:nvGrpSpPr>
          <p:cNvPr id="45" name="Group 25"/>
          <p:cNvGrpSpPr/>
          <p:nvPr/>
        </p:nvGrpSpPr>
        <p:grpSpPr>
          <a:xfrm>
            <a:off x="1390680" y="3327480"/>
            <a:ext cx="431640" cy="198360"/>
            <a:chOff x="1390680" y="3327480"/>
            <a:chExt cx="431640" cy="198360"/>
          </a:xfrm>
        </p:grpSpPr>
        <p:sp>
          <p:nvSpPr>
            <p:cNvPr id="46" name="Straight Connector 12"/>
            <p:cNvSpPr/>
            <p:nvPr/>
          </p:nvSpPr>
          <p:spPr>
            <a:xfrm>
              <a:off x="1434960" y="3489480"/>
              <a:ext cx="287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Straight Connector 17"/>
            <p:cNvSpPr/>
            <p:nvPr/>
          </p:nvSpPr>
          <p:spPr>
            <a:xfrm flipV="1">
              <a:off x="1722600" y="3454560"/>
              <a:ext cx="0" cy="71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Straight Connector 22"/>
            <p:cNvSpPr/>
            <p:nvPr/>
          </p:nvSpPr>
          <p:spPr>
            <a:xfrm flipV="1">
              <a:off x="1433520" y="3454560"/>
              <a:ext cx="0" cy="71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Box 19"/>
            <p:cNvSpPr/>
            <p:nvPr/>
          </p:nvSpPr>
          <p:spPr>
            <a:xfrm>
              <a:off x="1390680" y="3327480"/>
              <a:ext cx="4316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0</a:t>
              </a:r>
              <a:r>
                <a:rPr b="1" lang="el-G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μ</a:t>
              </a: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0" name="TextBox 6"/>
          <p:cNvSpPr/>
          <p:nvPr/>
        </p:nvSpPr>
        <p:spPr>
          <a:xfrm>
            <a:off x="1392120" y="1469880"/>
            <a:ext cx="28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6"/>
          <p:cNvSpPr/>
          <p:nvPr/>
        </p:nvSpPr>
        <p:spPr>
          <a:xfrm>
            <a:off x="3627360" y="1476360"/>
            <a:ext cx="28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6"/>
          <p:cNvSpPr/>
          <p:nvPr/>
        </p:nvSpPr>
        <p:spPr>
          <a:xfrm>
            <a:off x="1739880" y="3457440"/>
            <a:ext cx="28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Picture 12" descr="M:\PhD M.Leite\AnxA1\BCACID_Scores\Scope Pictures\100p_20X_MCBCS 3E.jpg"/>
          <p:cNvPicPr/>
          <p:nvPr/>
        </p:nvPicPr>
        <p:blipFill>
          <a:blip r:embed="rId4"/>
          <a:srcRect l="33854" t="13236" r="26404" b="21058"/>
          <a:stretch/>
        </p:blipFill>
        <p:spPr>
          <a:xfrm>
            <a:off x="3657600" y="3841920"/>
            <a:ext cx="1944720" cy="17874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grpSp>
        <p:nvGrpSpPr>
          <p:cNvPr id="54" name="Group 26"/>
          <p:cNvGrpSpPr/>
          <p:nvPr/>
        </p:nvGrpSpPr>
        <p:grpSpPr>
          <a:xfrm>
            <a:off x="4292640" y="3797280"/>
            <a:ext cx="433440" cy="198360"/>
            <a:chOff x="4292640" y="3797280"/>
            <a:chExt cx="433440" cy="198360"/>
          </a:xfrm>
        </p:grpSpPr>
        <p:sp>
          <p:nvSpPr>
            <p:cNvPr id="55" name="Straight Connector 27"/>
            <p:cNvSpPr/>
            <p:nvPr/>
          </p:nvSpPr>
          <p:spPr>
            <a:xfrm>
              <a:off x="4336920" y="3959280"/>
              <a:ext cx="289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Straight Connector 28"/>
            <p:cNvSpPr/>
            <p:nvPr/>
          </p:nvSpPr>
          <p:spPr>
            <a:xfrm flipV="1">
              <a:off x="4626000" y="3924360"/>
              <a:ext cx="0" cy="71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Straight Connector 29"/>
            <p:cNvSpPr/>
            <p:nvPr/>
          </p:nvSpPr>
          <p:spPr>
            <a:xfrm flipV="1">
              <a:off x="4335480" y="3924360"/>
              <a:ext cx="0" cy="71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Box 19"/>
            <p:cNvSpPr/>
            <p:nvPr/>
          </p:nvSpPr>
          <p:spPr>
            <a:xfrm>
              <a:off x="4292640" y="3797280"/>
              <a:ext cx="4334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0</a:t>
              </a:r>
              <a:r>
                <a:rPr b="1" lang="el-G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μ</a:t>
              </a: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9" name="TextBox 6"/>
          <p:cNvSpPr/>
          <p:nvPr/>
        </p:nvSpPr>
        <p:spPr>
          <a:xfrm>
            <a:off x="1389240" y="3557520"/>
            <a:ext cx="285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6"/>
          <p:cNvSpPr/>
          <p:nvPr/>
        </p:nvSpPr>
        <p:spPr>
          <a:xfrm>
            <a:off x="3622680" y="3551400"/>
            <a:ext cx="28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1" name="Group 40"/>
          <p:cNvGrpSpPr/>
          <p:nvPr/>
        </p:nvGrpSpPr>
        <p:grpSpPr>
          <a:xfrm>
            <a:off x="2708280" y="5408640"/>
            <a:ext cx="433440" cy="198360"/>
            <a:chOff x="2708280" y="5408640"/>
            <a:chExt cx="433440" cy="198360"/>
          </a:xfrm>
        </p:grpSpPr>
        <p:sp>
          <p:nvSpPr>
            <p:cNvPr id="62" name="Straight Connector 41"/>
            <p:cNvSpPr/>
            <p:nvPr/>
          </p:nvSpPr>
          <p:spPr>
            <a:xfrm>
              <a:off x="2752560" y="5570640"/>
              <a:ext cx="289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Straight Connector 42"/>
            <p:cNvSpPr/>
            <p:nvPr/>
          </p:nvSpPr>
          <p:spPr>
            <a:xfrm flipV="1">
              <a:off x="3041640" y="5535720"/>
              <a:ext cx="0" cy="71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Straight Connector 43"/>
            <p:cNvSpPr/>
            <p:nvPr/>
          </p:nvSpPr>
          <p:spPr>
            <a:xfrm flipV="1">
              <a:off x="2751120" y="5535720"/>
              <a:ext cx="0" cy="71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Box 19"/>
            <p:cNvSpPr/>
            <p:nvPr/>
          </p:nvSpPr>
          <p:spPr>
            <a:xfrm>
              <a:off x="2708280" y="5408640"/>
              <a:ext cx="4334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0</a:t>
              </a:r>
              <a:r>
                <a:rPr b="1" lang="el-G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μ</a:t>
              </a: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cxnSp>
        <p:nvCxnSpPr>
          <p:cNvPr id="66" name="Straight Arrow Connector 56"/>
          <p:cNvCxnSpPr/>
          <p:nvPr/>
        </p:nvCxnSpPr>
        <p:spPr>
          <a:xfrm>
            <a:off x="2276280" y="2626920"/>
            <a:ext cx="54360" cy="18324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67" name="Straight Arrow Connector 57"/>
          <p:cNvCxnSpPr/>
          <p:nvPr/>
        </p:nvCxnSpPr>
        <p:spPr>
          <a:xfrm flipH="1" flipV="1">
            <a:off x="2933280" y="3328560"/>
            <a:ext cx="144720" cy="14472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arrow" w="med"/>
          </a:ln>
        </p:spPr>
      </p:cxnSp>
      <p:grpSp>
        <p:nvGrpSpPr>
          <p:cNvPr id="68" name="Group 40"/>
          <p:cNvGrpSpPr/>
          <p:nvPr/>
        </p:nvGrpSpPr>
        <p:grpSpPr>
          <a:xfrm>
            <a:off x="3625920" y="3333600"/>
            <a:ext cx="433440" cy="198360"/>
            <a:chOff x="3625920" y="3333600"/>
            <a:chExt cx="433440" cy="198360"/>
          </a:xfrm>
        </p:grpSpPr>
        <p:sp>
          <p:nvSpPr>
            <p:cNvPr id="69" name="Straight Connector 45"/>
            <p:cNvSpPr/>
            <p:nvPr/>
          </p:nvSpPr>
          <p:spPr>
            <a:xfrm>
              <a:off x="3670200" y="3495960"/>
              <a:ext cx="289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Straight Connector 46"/>
            <p:cNvSpPr/>
            <p:nvPr/>
          </p:nvSpPr>
          <p:spPr>
            <a:xfrm flipV="1">
              <a:off x="3959280" y="3460320"/>
              <a:ext cx="0" cy="71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Straight Connector 50"/>
            <p:cNvSpPr/>
            <p:nvPr/>
          </p:nvSpPr>
          <p:spPr>
            <a:xfrm flipV="1">
              <a:off x="3668760" y="3460320"/>
              <a:ext cx="0" cy="71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Box 19"/>
            <p:cNvSpPr/>
            <p:nvPr/>
          </p:nvSpPr>
          <p:spPr>
            <a:xfrm>
              <a:off x="3625920" y="3333600"/>
              <a:ext cx="4334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0</a:t>
              </a:r>
              <a:r>
                <a:rPr b="1" lang="el-G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μ</a:t>
              </a: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0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1-01T11:57:37Z</dcterms:created>
  <dc:creator>Marcelo Sobral Leite</dc:creator>
  <dc:description/>
  <dc:language>en-US</dc:language>
  <cp:lastModifiedBy>Marcelo Sobral-Leite</cp:lastModifiedBy>
  <cp:lastPrinted>2014-09-08T08:30:29Z</cp:lastPrinted>
  <dcterms:modified xsi:type="dcterms:W3CDTF">2015-04-29T15:17:03Z</dcterms:modified>
  <cp:revision>413</cp:revision>
  <dc:subject/>
  <dc:title>Slide 1</dc:title>
</cp:coreProperties>
</file>